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pct" ContentType="image/x-pi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FC9E63-EC67-498C-B423-A908F125F95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7E13FF-F6F7-4577-BF82-914F3815F2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64D1BD-F661-428C-B747-283765C48B7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858391-1AC6-44B5-8669-539723E09CD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30536D-0516-4DB6-B104-A27DFE2BD03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1053E1-3A09-4033-B2D8-D8E343DC22C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0E2AFE-6F07-467B-A815-DBC0F6F758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EE3CEB-7C64-4F82-9AAA-36AF2A6E08F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CD09F2-01D9-4206-8878-6AAB5A0407A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CE6E55-8364-4DC2-92C5-A91374471A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37D441-E3CE-4F89-81ED-15C043C69F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D15330-3C72-4900-9C55-C5132824E8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4244805-8426-488A-ADD0-5819B3E4D04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pct"/><Relationship Id="rId3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896760" y="768240"/>
            <a:ext cx="2340000" cy="1710000"/>
            <a:chOff x="896760" y="768240"/>
            <a:chExt cx="2340000" cy="1710000"/>
          </a:xfrm>
        </p:grpSpPr>
        <p:sp>
          <p:nvSpPr>
            <p:cNvPr id="42" name=""/>
            <p:cNvSpPr/>
            <p:nvPr/>
          </p:nvSpPr>
          <p:spPr>
            <a:xfrm>
              <a:off x="896760" y="768240"/>
              <a:ext cx="2340000" cy="171000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 flipV="1">
              <a:off x="1144800" y="988920"/>
              <a:ext cx="1440" cy="1071360"/>
            </a:xfrm>
            <a:prstGeom prst="line">
              <a:avLst/>
            </a:prstGeom>
            <a:ln w="64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1238040" y="1223640"/>
              <a:ext cx="125280" cy="8362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1240920" y="1226520"/>
              <a:ext cx="119880" cy="83052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1549800" y="1830240"/>
              <a:ext cx="127080" cy="2300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1553040" y="1833480"/>
              <a:ext cx="120960" cy="22356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1862640" y="1997280"/>
              <a:ext cx="127080" cy="62640"/>
            </a:xfrm>
            <a:prstGeom prst="rect">
              <a:avLst/>
            </a:prstGeom>
            <a:solidFill>
              <a:srgbClr val="9999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840" bIns="15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1865880" y="2000520"/>
              <a:ext cx="121320" cy="5616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360" bIns="9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2175840" y="2014560"/>
              <a:ext cx="125640" cy="45720"/>
            </a:xfrm>
            <a:prstGeom prst="rect">
              <a:avLst/>
            </a:prstGeom>
            <a:solidFill>
              <a:srgbClr val="9999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" bIns="-1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2179080" y="2017800"/>
              <a:ext cx="119520" cy="3924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560" bIns="-7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2489040" y="1781640"/>
              <a:ext cx="124200" cy="278640"/>
            </a:xfrm>
            <a:prstGeom prst="rect">
              <a:avLst/>
            </a:prstGeom>
            <a:solidFill>
              <a:srgbClr val="9999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492280" y="1784880"/>
              <a:ext cx="118080" cy="27216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2800440" y="1909080"/>
              <a:ext cx="125640" cy="1508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2803680" y="1912320"/>
              <a:ext cx="119520" cy="14472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 flipV="1">
              <a:off x="1299600" y="1143000"/>
              <a:ext cx="1080" cy="802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480" bIns="33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1278720" y="1143360"/>
              <a:ext cx="421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 flipV="1">
              <a:off x="1612440" y="1688400"/>
              <a:ext cx="1440" cy="141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1592280" y="1688760"/>
              <a:ext cx="421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 flipV="1">
              <a:off x="1925640" y="1986480"/>
              <a:ext cx="1080" cy="10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1905120" y="1986480"/>
              <a:ext cx="421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 flipV="1">
              <a:off x="2238840" y="2001960"/>
              <a:ext cx="1440" cy="122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560" bIns="-34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2218320" y="2001960"/>
              <a:ext cx="421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 flipV="1">
              <a:off x="2550240" y="1721520"/>
              <a:ext cx="1440" cy="597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960" bIns="12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2530080" y="1721520"/>
              <a:ext cx="4104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 flipV="1">
              <a:off x="2862000" y="1885320"/>
              <a:ext cx="1440" cy="234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2841480" y="1885680"/>
              <a:ext cx="421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1144800" y="988920"/>
              <a:ext cx="1440" cy="10713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1129320" y="2060280"/>
              <a:ext cx="154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1129320" y="1909080"/>
              <a:ext cx="154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1129320" y="1752840"/>
              <a:ext cx="154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1129320" y="1601640"/>
              <a:ext cx="154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1129320" y="1449000"/>
              <a:ext cx="154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1129320" y="1296360"/>
              <a:ext cx="154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1129320" y="1141560"/>
              <a:ext cx="154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1129320" y="988920"/>
              <a:ext cx="154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1144800" y="2060280"/>
              <a:ext cx="1872720" cy="1440"/>
            </a:xfrm>
            <a:prstGeom prst="line">
              <a:avLst/>
            </a:prstGeom>
            <a:ln w="18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 flipV="1">
              <a:off x="1144800" y="2059920"/>
              <a:ext cx="144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 flipV="1">
              <a:off x="1458360" y="2059920"/>
              <a:ext cx="108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 flipV="1">
              <a:off x="1771560" y="2059920"/>
              <a:ext cx="108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 flipV="1">
              <a:off x="2083320" y="2059920"/>
              <a:ext cx="108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 flipV="1">
              <a:off x="2396160" y="2059920"/>
              <a:ext cx="144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 flipV="1">
              <a:off x="2707560" y="2059920"/>
              <a:ext cx="144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 flipV="1">
              <a:off x="3021120" y="2059920"/>
              <a:ext cx="108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1881360" y="818280"/>
              <a:ext cx="243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MMP 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1064160" y="201168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1019880" y="18586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1064160" y="170424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1019880" y="15512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1064160" y="14004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1019880" y="12474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1064160" y="10929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1019880" y="9399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 rot="5400000">
              <a:off x="1216800" y="2190960"/>
              <a:ext cx="235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 rot="5400000">
              <a:off x="1192680" y="2154960"/>
              <a:ext cx="160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RN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 rot="5400000">
              <a:off x="1531440" y="222228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 rot="5400000">
              <a:off x="1460520" y="222768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 rot="5400000">
              <a:off x="1474200" y="2148840"/>
              <a:ext cx="1548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 rot="5400000">
              <a:off x="1845000" y="222228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 rot="5400000">
              <a:off x="1773360" y="222768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 rot="5400000">
              <a:off x="1779120" y="215784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Long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 rot="5400000">
              <a:off x="2147760" y="2237760"/>
              <a:ext cx="322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 rot="5400000">
              <a:off x="2086560" y="222768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 rot="5400000">
              <a:off x="2086200" y="2165760"/>
              <a:ext cx="183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Short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 rot="5400000">
              <a:off x="2468160" y="222228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 rot="5400000">
              <a:off x="2398320" y="222768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 rot="5400000">
              <a:off x="2356920" y="2209320"/>
              <a:ext cx="26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4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 rot="5400000">
              <a:off x="2781360" y="222228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 rot="5400000">
              <a:off x="2757600" y="2182320"/>
              <a:ext cx="217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Empt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 rot="5400000">
              <a:off x="2691720" y="2184480"/>
              <a:ext cx="22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Vector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 rot="16200000">
              <a:off x="804240" y="1477800"/>
              <a:ext cx="329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gene/18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2" name=""/>
          <p:cNvGrpSpPr/>
          <p:nvPr/>
        </p:nvGrpSpPr>
        <p:grpSpPr>
          <a:xfrm>
            <a:off x="3581280" y="768240"/>
            <a:ext cx="2340000" cy="1710000"/>
            <a:chOff x="3581280" y="768240"/>
            <a:chExt cx="2340000" cy="1710000"/>
          </a:xfrm>
        </p:grpSpPr>
        <p:sp>
          <p:nvSpPr>
            <p:cNvPr id="113" name=""/>
            <p:cNvSpPr/>
            <p:nvPr/>
          </p:nvSpPr>
          <p:spPr>
            <a:xfrm>
              <a:off x="3581280" y="768240"/>
              <a:ext cx="2340000" cy="171000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 flipV="1">
              <a:off x="3833640" y="1000080"/>
              <a:ext cx="1080" cy="969120"/>
            </a:xfrm>
            <a:prstGeom prst="line">
              <a:avLst/>
            </a:prstGeom>
            <a:ln w="64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3928320" y="1881360"/>
              <a:ext cx="124560" cy="87840"/>
            </a:xfrm>
            <a:prstGeom prst="rect">
              <a:avLst/>
            </a:prstGeom>
            <a:solidFill>
              <a:srgbClr val="9999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1040" bIns="41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3931560" y="1884240"/>
              <a:ext cx="118080" cy="8208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280" bIns="35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4240800" y="1802160"/>
              <a:ext cx="125640" cy="1670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4243680" y="1805400"/>
              <a:ext cx="119880" cy="16092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4554720" y="1633320"/>
              <a:ext cx="122760" cy="3362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4557960" y="1636560"/>
              <a:ext cx="116640" cy="33012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4865760" y="1906560"/>
              <a:ext cx="126000" cy="63000"/>
            </a:xfrm>
            <a:prstGeom prst="rect">
              <a:avLst/>
            </a:prstGeom>
            <a:solidFill>
              <a:srgbClr val="9999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200" bIns="16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4868640" y="1909800"/>
              <a:ext cx="119520" cy="5688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080" bIns="100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5179320" y="1947600"/>
              <a:ext cx="126000" cy="21600"/>
            </a:xfrm>
            <a:prstGeom prst="rect">
              <a:avLst/>
            </a:prstGeom>
            <a:solidFill>
              <a:srgbClr val="9999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0" bIns="-25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5182560" y="1950840"/>
              <a:ext cx="119520" cy="1548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320" bIns="-31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5491800" y="1939680"/>
              <a:ext cx="126000" cy="29520"/>
            </a:xfrm>
            <a:prstGeom prst="rect">
              <a:avLst/>
            </a:prstGeom>
            <a:solidFill>
              <a:srgbClr val="9999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5495040" y="1942560"/>
              <a:ext cx="119520" cy="2376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 flipV="1">
              <a:off x="3989880" y="1840320"/>
              <a:ext cx="1440" cy="41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3969360" y="1840320"/>
              <a:ext cx="424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 flipV="1">
              <a:off x="4303800" y="1766160"/>
              <a:ext cx="1080" cy="360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0" bIns="-10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4283280" y="1766160"/>
              <a:ext cx="424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 flipV="1">
              <a:off x="4614840" y="1146960"/>
              <a:ext cx="1080" cy="4860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4593960" y="1146960"/>
              <a:ext cx="424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 flipV="1">
              <a:off x="4928400" y="1883880"/>
              <a:ext cx="1440" cy="21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4908240" y="1884240"/>
              <a:ext cx="424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 flipV="1">
              <a:off x="5240880" y="1915920"/>
              <a:ext cx="1440" cy="313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480" bIns="-154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5220360" y="1916280"/>
              <a:ext cx="424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 flipV="1">
              <a:off x="5555160" y="1928880"/>
              <a:ext cx="1080" cy="10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5534640" y="1928880"/>
              <a:ext cx="424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3833640" y="1000080"/>
              <a:ext cx="1080" cy="9691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3817800" y="1969560"/>
              <a:ext cx="154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3817800" y="1775520"/>
              <a:ext cx="154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3817800" y="1581480"/>
              <a:ext cx="154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3817800" y="1386720"/>
              <a:ext cx="154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3817800" y="1194120"/>
              <a:ext cx="154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3817800" y="1000080"/>
              <a:ext cx="154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3833640" y="1969560"/>
              <a:ext cx="1877040" cy="1440"/>
            </a:xfrm>
            <a:prstGeom prst="line">
              <a:avLst/>
            </a:prstGeom>
            <a:ln w="18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 flipV="1">
              <a:off x="3833640" y="1969560"/>
              <a:ext cx="1080" cy="252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 flipV="1">
              <a:off x="4147560" y="1969560"/>
              <a:ext cx="1440" cy="252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 flipV="1">
              <a:off x="4460040" y="1969560"/>
              <a:ext cx="1080" cy="252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 flipV="1">
              <a:off x="4772520" y="1969560"/>
              <a:ext cx="1080" cy="252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 flipV="1">
              <a:off x="5085000" y="1969560"/>
              <a:ext cx="1080" cy="252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 flipV="1">
              <a:off x="5398560" y="1969560"/>
              <a:ext cx="1440" cy="252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 flipV="1">
              <a:off x="5712840" y="1969560"/>
              <a:ext cx="1080" cy="252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4701960" y="818640"/>
              <a:ext cx="243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MMP 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3746520" y="19191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3702600" y="17251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3746520" y="153072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3702600" y="13363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3746520" y="114228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3702600" y="9478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 rot="5400000">
              <a:off x="3911400" y="2100600"/>
              <a:ext cx="235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 rot="5400000">
              <a:off x="3884040" y="2065680"/>
              <a:ext cx="160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RN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 rot="5400000">
              <a:off x="4225680" y="213588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 rot="5400000">
              <a:off x="4155480" y="214056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 rot="5400000">
              <a:off x="4167720" y="2061720"/>
              <a:ext cx="1548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 rot="5400000">
              <a:off x="4537800" y="213588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 rot="5400000">
              <a:off x="4467600" y="214056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 rot="5400000">
              <a:off x="4475160" y="207036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Long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 rot="5400000">
              <a:off x="4843080" y="2148840"/>
              <a:ext cx="322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 rot="5400000">
              <a:off x="4781880" y="214056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 rot="5400000">
              <a:off x="4779000" y="2075400"/>
              <a:ext cx="183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Short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 rot="5400000">
              <a:off x="5162760" y="213588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 rot="5400000">
              <a:off x="5092560" y="214056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 rot="5400000">
              <a:off x="5050440" y="2116440"/>
              <a:ext cx="26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4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 rot="5400000">
              <a:off x="5476680" y="213588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 rot="5400000">
              <a:off x="5454000" y="2095200"/>
              <a:ext cx="217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Empt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 rot="5400000">
              <a:off x="5385240" y="2095560"/>
              <a:ext cx="22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Vector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 rot="16200000">
              <a:off x="3492000" y="1446120"/>
              <a:ext cx="329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gene/18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9" name=""/>
          <p:cNvGrpSpPr/>
          <p:nvPr/>
        </p:nvGrpSpPr>
        <p:grpSpPr>
          <a:xfrm>
            <a:off x="896760" y="2590920"/>
            <a:ext cx="2340000" cy="1709640"/>
            <a:chOff x="896760" y="2590920"/>
            <a:chExt cx="2340000" cy="1709640"/>
          </a:xfrm>
        </p:grpSpPr>
        <p:sp>
          <p:nvSpPr>
            <p:cNvPr id="180" name=""/>
            <p:cNvSpPr/>
            <p:nvPr/>
          </p:nvSpPr>
          <p:spPr>
            <a:xfrm>
              <a:off x="896760" y="2590920"/>
              <a:ext cx="2340000" cy="170964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 flipV="1">
              <a:off x="1191240" y="2793240"/>
              <a:ext cx="1080" cy="979200"/>
            </a:xfrm>
            <a:prstGeom prst="line">
              <a:avLst/>
            </a:prstGeom>
            <a:ln w="64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1282680" y="3560760"/>
              <a:ext cx="122400" cy="2116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1285560" y="3564000"/>
              <a:ext cx="116640" cy="20520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1587960" y="3189600"/>
              <a:ext cx="122760" cy="582840"/>
            </a:xfrm>
            <a:prstGeom prst="rect">
              <a:avLst/>
            </a:prstGeom>
            <a:solidFill>
              <a:srgbClr val="9999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1591200" y="3192840"/>
              <a:ext cx="116280" cy="57636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1893240" y="3507120"/>
              <a:ext cx="124560" cy="265320"/>
            </a:xfrm>
            <a:prstGeom prst="rect">
              <a:avLst/>
            </a:prstGeom>
            <a:solidFill>
              <a:srgbClr val="9999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1896480" y="3510360"/>
              <a:ext cx="118080" cy="25884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2200320" y="3342600"/>
              <a:ext cx="122760" cy="4298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2203560" y="3345840"/>
              <a:ext cx="116640" cy="42336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2505960" y="3442320"/>
              <a:ext cx="120960" cy="330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2509200" y="3445560"/>
              <a:ext cx="114840" cy="32364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2809800" y="3475800"/>
              <a:ext cx="122760" cy="2970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2813040" y="3479040"/>
              <a:ext cx="116280" cy="29052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 flipV="1">
              <a:off x="1343880" y="3530520"/>
              <a:ext cx="1080" cy="298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1321920" y="3530880"/>
              <a:ext cx="453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 flipV="1">
              <a:off x="1647720" y="2921040"/>
              <a:ext cx="1080" cy="268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1625760" y="2921040"/>
              <a:ext cx="453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 flipV="1">
              <a:off x="1954800" y="3399840"/>
              <a:ext cx="1440" cy="1072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1932840" y="3399840"/>
              <a:ext cx="4680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 flipV="1">
              <a:off x="2260440" y="3218040"/>
              <a:ext cx="1080" cy="124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2238120" y="3218040"/>
              <a:ext cx="453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 flipV="1">
              <a:off x="2565720" y="3180240"/>
              <a:ext cx="1440" cy="262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2543760" y="3180240"/>
              <a:ext cx="453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 flipV="1">
              <a:off x="2871360" y="3410640"/>
              <a:ext cx="1080" cy="64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2849040" y="3410640"/>
              <a:ext cx="453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1191240" y="2793240"/>
              <a:ext cx="1080" cy="9792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1173600" y="3772800"/>
              <a:ext cx="172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1173600" y="3610080"/>
              <a:ext cx="172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1173600" y="3445560"/>
              <a:ext cx="172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1173600" y="3282840"/>
              <a:ext cx="172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1173600" y="3120120"/>
              <a:ext cx="172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1173600" y="2955960"/>
              <a:ext cx="172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1173600" y="2793240"/>
              <a:ext cx="172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1191240" y="3772800"/>
              <a:ext cx="1838880" cy="1080"/>
            </a:xfrm>
            <a:prstGeom prst="line">
              <a:avLst/>
            </a:prstGeom>
            <a:ln w="18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 flipV="1">
              <a:off x="1191240" y="3772440"/>
              <a:ext cx="1080" cy="248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 flipV="1">
              <a:off x="1496520" y="3772440"/>
              <a:ext cx="1440" cy="248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 flipV="1">
              <a:off x="1803600" y="3772440"/>
              <a:ext cx="1440" cy="248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 flipV="1">
              <a:off x="2109240" y="3772440"/>
              <a:ext cx="1080" cy="248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 flipV="1">
              <a:off x="2414520" y="3772440"/>
              <a:ext cx="1440" cy="248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 flipV="1">
              <a:off x="2720160" y="3772440"/>
              <a:ext cx="1080" cy="248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 flipV="1">
              <a:off x="3025440" y="3772440"/>
              <a:ext cx="1080" cy="248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2027880" y="2641680"/>
              <a:ext cx="2430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MMP 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1085040" y="372024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1037160" y="35575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>
              <a:off x="1085040" y="339372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1037160" y="32306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1085040" y="306792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1037160" y="29037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1085040" y="274068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 rot="5400000">
              <a:off x="1266120" y="3908880"/>
              <a:ext cx="235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 rot="5400000">
              <a:off x="1234080" y="3869640"/>
              <a:ext cx="160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RN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 rot="5400000">
              <a:off x="1575000" y="393912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 rot="5400000">
              <a:off x="1501920" y="394452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 rot="5400000">
              <a:off x="1507680" y="3867120"/>
              <a:ext cx="1548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 rot="5400000">
              <a:off x="1882080" y="393912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 rot="5400000">
              <a:off x="1805400" y="394452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 rot="5400000">
              <a:off x="1806840" y="387288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Long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 rot="5400000">
              <a:off x="2176920" y="3949560"/>
              <a:ext cx="322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 rot="5400000">
              <a:off x="2114280" y="394452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 rot="5400000">
              <a:off x="2106000" y="3882240"/>
              <a:ext cx="183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Short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 rot="5400000">
              <a:off x="2493000" y="393912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 rot="5400000">
              <a:off x="2418480" y="394452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 rot="5400000">
              <a:off x="2370600" y="3923640"/>
              <a:ext cx="26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4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 rot="5400000">
              <a:off x="2800080" y="393912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 rot="5400000">
              <a:off x="2773080" y="3900600"/>
              <a:ext cx="217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Empt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 rot="5400000">
              <a:off x="2701080" y="3899520"/>
              <a:ext cx="22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Vector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 rot="16200000">
              <a:off x="832320" y="3247200"/>
              <a:ext cx="329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gene/18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48" name=""/>
          <p:cNvGrpSpPr/>
          <p:nvPr/>
        </p:nvGrpSpPr>
        <p:grpSpPr>
          <a:xfrm>
            <a:off x="3581280" y="2590920"/>
            <a:ext cx="2340000" cy="1709280"/>
            <a:chOff x="3581280" y="2590920"/>
            <a:chExt cx="2340000" cy="1709280"/>
          </a:xfrm>
        </p:grpSpPr>
        <p:sp>
          <p:nvSpPr>
            <p:cNvPr id="249" name=""/>
            <p:cNvSpPr/>
            <p:nvPr/>
          </p:nvSpPr>
          <p:spPr>
            <a:xfrm>
              <a:off x="3581280" y="2590920"/>
              <a:ext cx="2340000" cy="170928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 flipV="1">
              <a:off x="3827160" y="2819160"/>
              <a:ext cx="1080" cy="997200"/>
            </a:xfrm>
            <a:prstGeom prst="line">
              <a:avLst/>
            </a:prstGeom>
            <a:ln w="64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4232160" y="3547800"/>
              <a:ext cx="126000" cy="2682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4235400" y="3550680"/>
              <a:ext cx="119520" cy="26208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4858200" y="3303000"/>
              <a:ext cx="126000" cy="5130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4861440" y="3306240"/>
              <a:ext cx="119520" cy="50652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5170680" y="3460680"/>
              <a:ext cx="126000" cy="3553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5173920" y="3463920"/>
              <a:ext cx="119520" cy="34884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3981600" y="3816360"/>
              <a:ext cx="144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3961080" y="3816360"/>
              <a:ext cx="439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 flipV="1">
              <a:off x="4295520" y="3259800"/>
              <a:ext cx="1080" cy="2880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4273200" y="3259800"/>
              <a:ext cx="45720" cy="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4607640" y="3816360"/>
              <a:ext cx="10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4585680" y="3816360"/>
              <a:ext cx="4572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 flipV="1">
              <a:off x="4919760" y="2936520"/>
              <a:ext cx="1080" cy="366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4897800" y="2936520"/>
              <a:ext cx="442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 flipV="1">
              <a:off x="5233320" y="3142080"/>
              <a:ext cx="1440" cy="3182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5211720" y="3142080"/>
              <a:ext cx="43920" cy="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5546160" y="3816360"/>
              <a:ext cx="10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5525280" y="3816360"/>
              <a:ext cx="442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3827160" y="2819160"/>
              <a:ext cx="1080" cy="9972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3812760" y="3816360"/>
              <a:ext cx="140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"/>
            <p:cNvSpPr/>
            <p:nvPr/>
          </p:nvSpPr>
          <p:spPr>
            <a:xfrm>
              <a:off x="3812760" y="3705480"/>
              <a:ext cx="140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3812760" y="3594240"/>
              <a:ext cx="140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>
              <a:off x="3812760" y="3481920"/>
              <a:ext cx="140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"/>
            <p:cNvSpPr/>
            <p:nvPr/>
          </p:nvSpPr>
          <p:spPr>
            <a:xfrm>
              <a:off x="3812760" y="3370680"/>
              <a:ext cx="140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"/>
            <p:cNvSpPr/>
            <p:nvPr/>
          </p:nvSpPr>
          <p:spPr>
            <a:xfrm>
              <a:off x="3812760" y="3263040"/>
              <a:ext cx="140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"/>
            <p:cNvSpPr/>
            <p:nvPr/>
          </p:nvSpPr>
          <p:spPr>
            <a:xfrm>
              <a:off x="3812760" y="3152160"/>
              <a:ext cx="140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"/>
            <p:cNvSpPr/>
            <p:nvPr/>
          </p:nvSpPr>
          <p:spPr>
            <a:xfrm>
              <a:off x="3812760" y="3040920"/>
              <a:ext cx="140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3812760" y="2930040"/>
              <a:ext cx="14040" cy="1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"/>
            <p:cNvSpPr/>
            <p:nvPr/>
          </p:nvSpPr>
          <p:spPr>
            <a:xfrm>
              <a:off x="3812760" y="2819160"/>
              <a:ext cx="1404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"/>
            <p:cNvSpPr/>
            <p:nvPr/>
          </p:nvSpPr>
          <p:spPr>
            <a:xfrm>
              <a:off x="3827160" y="3816360"/>
              <a:ext cx="1876320" cy="1440"/>
            </a:xfrm>
            <a:prstGeom prst="line">
              <a:avLst/>
            </a:prstGeom>
            <a:ln w="18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 flipV="1">
              <a:off x="3827160" y="3816360"/>
              <a:ext cx="1080" cy="23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"/>
            <p:cNvSpPr/>
            <p:nvPr/>
          </p:nvSpPr>
          <p:spPr>
            <a:xfrm flipV="1">
              <a:off x="4140720" y="3816360"/>
              <a:ext cx="1440" cy="23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"/>
            <p:cNvSpPr/>
            <p:nvPr/>
          </p:nvSpPr>
          <p:spPr>
            <a:xfrm flipV="1">
              <a:off x="4451400" y="3816360"/>
              <a:ext cx="1440" cy="23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"/>
            <p:cNvSpPr/>
            <p:nvPr/>
          </p:nvSpPr>
          <p:spPr>
            <a:xfrm flipV="1">
              <a:off x="4765320" y="3816360"/>
              <a:ext cx="1080" cy="23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"/>
            <p:cNvSpPr/>
            <p:nvPr/>
          </p:nvSpPr>
          <p:spPr>
            <a:xfrm flipV="1">
              <a:off x="5077440" y="3816360"/>
              <a:ext cx="1080" cy="23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"/>
            <p:cNvSpPr/>
            <p:nvPr/>
          </p:nvSpPr>
          <p:spPr>
            <a:xfrm flipV="1">
              <a:off x="5391000" y="3816360"/>
              <a:ext cx="1440" cy="23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"/>
            <p:cNvSpPr/>
            <p:nvPr/>
          </p:nvSpPr>
          <p:spPr>
            <a:xfrm flipV="1">
              <a:off x="5703840" y="3816360"/>
              <a:ext cx="1080" cy="23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"/>
            <p:cNvSpPr/>
            <p:nvPr/>
          </p:nvSpPr>
          <p:spPr>
            <a:xfrm>
              <a:off x="4613760" y="2642040"/>
              <a:ext cx="2858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MMP 1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"/>
            <p:cNvSpPr/>
            <p:nvPr/>
          </p:nvSpPr>
          <p:spPr>
            <a:xfrm>
              <a:off x="3721320" y="37569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"/>
            <p:cNvSpPr/>
            <p:nvPr/>
          </p:nvSpPr>
          <p:spPr>
            <a:xfrm>
              <a:off x="3682080" y="36460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3682080" y="35348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"/>
            <p:cNvSpPr/>
            <p:nvPr/>
          </p:nvSpPr>
          <p:spPr>
            <a:xfrm>
              <a:off x="3682080" y="34239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"/>
            <p:cNvSpPr/>
            <p:nvPr/>
          </p:nvSpPr>
          <p:spPr>
            <a:xfrm>
              <a:off x="3682080" y="33130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"/>
            <p:cNvSpPr/>
            <p:nvPr/>
          </p:nvSpPr>
          <p:spPr>
            <a:xfrm>
              <a:off x="3721320" y="320508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"/>
            <p:cNvSpPr/>
            <p:nvPr/>
          </p:nvSpPr>
          <p:spPr>
            <a:xfrm>
              <a:off x="3682080" y="30927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"/>
            <p:cNvSpPr/>
            <p:nvPr/>
          </p:nvSpPr>
          <p:spPr>
            <a:xfrm>
              <a:off x="3682080" y="29815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"/>
            <p:cNvSpPr/>
            <p:nvPr/>
          </p:nvSpPr>
          <p:spPr>
            <a:xfrm>
              <a:off x="3682080" y="28706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"/>
            <p:cNvSpPr/>
            <p:nvPr/>
          </p:nvSpPr>
          <p:spPr>
            <a:xfrm>
              <a:off x="3682080" y="27597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"/>
            <p:cNvSpPr/>
            <p:nvPr/>
          </p:nvSpPr>
          <p:spPr>
            <a:xfrm rot="5400000">
              <a:off x="3907080" y="3950280"/>
              <a:ext cx="235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"/>
            <p:cNvSpPr/>
            <p:nvPr/>
          </p:nvSpPr>
          <p:spPr>
            <a:xfrm rot="5400000">
              <a:off x="3886560" y="3916800"/>
              <a:ext cx="160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RN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"/>
            <p:cNvSpPr/>
            <p:nvPr/>
          </p:nvSpPr>
          <p:spPr>
            <a:xfrm rot="5400000">
              <a:off x="4218840" y="398412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"/>
            <p:cNvSpPr/>
            <p:nvPr/>
          </p:nvSpPr>
          <p:spPr>
            <a:xfrm rot="5400000">
              <a:off x="4151880" y="398952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"/>
            <p:cNvSpPr/>
            <p:nvPr/>
          </p:nvSpPr>
          <p:spPr>
            <a:xfrm rot="5400000">
              <a:off x="4172040" y="3909240"/>
              <a:ext cx="1548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"/>
            <p:cNvSpPr/>
            <p:nvPr/>
          </p:nvSpPr>
          <p:spPr>
            <a:xfrm rot="5400000">
              <a:off x="4532040" y="398412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"/>
            <p:cNvSpPr/>
            <p:nvPr/>
          </p:nvSpPr>
          <p:spPr>
            <a:xfrm rot="5400000">
              <a:off x="4465440" y="398952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"/>
            <p:cNvSpPr/>
            <p:nvPr/>
          </p:nvSpPr>
          <p:spPr>
            <a:xfrm rot="5400000">
              <a:off x="4477320" y="392148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Long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"/>
            <p:cNvSpPr/>
            <p:nvPr/>
          </p:nvSpPr>
          <p:spPr>
            <a:xfrm rot="5400000">
              <a:off x="4833720" y="3996360"/>
              <a:ext cx="322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"/>
            <p:cNvSpPr/>
            <p:nvPr/>
          </p:nvSpPr>
          <p:spPr>
            <a:xfrm rot="5400000">
              <a:off x="4777200" y="398952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"/>
            <p:cNvSpPr/>
            <p:nvPr/>
          </p:nvSpPr>
          <p:spPr>
            <a:xfrm rot="5400000">
              <a:off x="4783320" y="3924720"/>
              <a:ext cx="183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Short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"/>
            <p:cNvSpPr/>
            <p:nvPr/>
          </p:nvSpPr>
          <p:spPr>
            <a:xfrm rot="5400000">
              <a:off x="5158440" y="398412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"/>
            <p:cNvSpPr/>
            <p:nvPr/>
          </p:nvSpPr>
          <p:spPr>
            <a:xfrm rot="5400000">
              <a:off x="5091480" y="398952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"/>
            <p:cNvSpPr/>
            <p:nvPr/>
          </p:nvSpPr>
          <p:spPr>
            <a:xfrm rot="5400000">
              <a:off x="5054040" y="3967560"/>
              <a:ext cx="26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4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"/>
            <p:cNvSpPr/>
            <p:nvPr/>
          </p:nvSpPr>
          <p:spPr>
            <a:xfrm rot="5400000">
              <a:off x="5470560" y="398412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"/>
            <p:cNvSpPr/>
            <p:nvPr/>
          </p:nvSpPr>
          <p:spPr>
            <a:xfrm rot="5400000">
              <a:off x="5451120" y="3943080"/>
              <a:ext cx="217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Empt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"/>
            <p:cNvSpPr/>
            <p:nvPr/>
          </p:nvSpPr>
          <p:spPr>
            <a:xfrm rot="5400000">
              <a:off x="5388840" y="3943800"/>
              <a:ext cx="22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Vector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"/>
            <p:cNvSpPr/>
            <p:nvPr/>
          </p:nvSpPr>
          <p:spPr>
            <a:xfrm rot="16200000">
              <a:off x="3447000" y="3325320"/>
              <a:ext cx="372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genes/18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17" name=""/>
          <p:cNvGrpSpPr/>
          <p:nvPr/>
        </p:nvGrpSpPr>
        <p:grpSpPr>
          <a:xfrm>
            <a:off x="896760" y="4427640"/>
            <a:ext cx="2340000" cy="1709640"/>
            <a:chOff x="896760" y="4427640"/>
            <a:chExt cx="2340000" cy="1709640"/>
          </a:xfrm>
        </p:grpSpPr>
        <p:sp>
          <p:nvSpPr>
            <p:cNvPr id="318" name=""/>
            <p:cNvSpPr/>
            <p:nvPr/>
          </p:nvSpPr>
          <p:spPr>
            <a:xfrm>
              <a:off x="896760" y="4427640"/>
              <a:ext cx="2340000" cy="170964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"/>
            <p:cNvSpPr/>
            <p:nvPr/>
          </p:nvSpPr>
          <p:spPr>
            <a:xfrm flipV="1">
              <a:off x="1161360" y="4691880"/>
              <a:ext cx="1080" cy="970920"/>
            </a:xfrm>
            <a:prstGeom prst="line">
              <a:avLst/>
            </a:prstGeom>
            <a:ln w="64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"/>
            <p:cNvSpPr/>
            <p:nvPr/>
          </p:nvSpPr>
          <p:spPr>
            <a:xfrm>
              <a:off x="1253880" y="5104440"/>
              <a:ext cx="122760" cy="558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"/>
            <p:cNvSpPr/>
            <p:nvPr/>
          </p:nvSpPr>
          <p:spPr>
            <a:xfrm>
              <a:off x="1257120" y="5107680"/>
              <a:ext cx="116280" cy="55260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"/>
            <p:cNvSpPr/>
            <p:nvPr/>
          </p:nvSpPr>
          <p:spPr>
            <a:xfrm>
              <a:off x="1564200" y="4995720"/>
              <a:ext cx="124200" cy="6674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"/>
            <p:cNvSpPr/>
            <p:nvPr/>
          </p:nvSpPr>
          <p:spPr>
            <a:xfrm>
              <a:off x="1567440" y="4998960"/>
              <a:ext cx="117720" cy="66132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"/>
            <p:cNvSpPr/>
            <p:nvPr/>
          </p:nvSpPr>
          <p:spPr>
            <a:xfrm>
              <a:off x="1874520" y="5251680"/>
              <a:ext cx="122760" cy="411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"/>
            <p:cNvSpPr/>
            <p:nvPr/>
          </p:nvSpPr>
          <p:spPr>
            <a:xfrm>
              <a:off x="1877400" y="5254560"/>
              <a:ext cx="116640" cy="40572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"/>
            <p:cNvSpPr/>
            <p:nvPr/>
          </p:nvSpPr>
          <p:spPr>
            <a:xfrm>
              <a:off x="2184480" y="5110920"/>
              <a:ext cx="124560" cy="5522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"/>
            <p:cNvSpPr/>
            <p:nvPr/>
          </p:nvSpPr>
          <p:spPr>
            <a:xfrm>
              <a:off x="2187720" y="5114160"/>
              <a:ext cx="118080" cy="54612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"/>
            <p:cNvSpPr/>
            <p:nvPr/>
          </p:nvSpPr>
          <p:spPr>
            <a:xfrm>
              <a:off x="2494800" y="5057280"/>
              <a:ext cx="122760" cy="6058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"/>
            <p:cNvSpPr/>
            <p:nvPr/>
          </p:nvSpPr>
          <p:spPr>
            <a:xfrm>
              <a:off x="2498040" y="5060520"/>
              <a:ext cx="116280" cy="59976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"/>
            <p:cNvSpPr/>
            <p:nvPr/>
          </p:nvSpPr>
          <p:spPr>
            <a:xfrm>
              <a:off x="2805120" y="5194800"/>
              <a:ext cx="122760" cy="4683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"/>
            <p:cNvSpPr/>
            <p:nvPr/>
          </p:nvSpPr>
          <p:spPr>
            <a:xfrm>
              <a:off x="2808360" y="5198040"/>
              <a:ext cx="116280" cy="46224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"/>
            <p:cNvSpPr/>
            <p:nvPr/>
          </p:nvSpPr>
          <p:spPr>
            <a:xfrm flipV="1">
              <a:off x="1315440" y="5013000"/>
              <a:ext cx="1440" cy="9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4280" bIns="44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"/>
            <p:cNvSpPr/>
            <p:nvPr/>
          </p:nvSpPr>
          <p:spPr>
            <a:xfrm>
              <a:off x="1293480" y="5013360"/>
              <a:ext cx="453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"/>
            <p:cNvSpPr/>
            <p:nvPr/>
          </p:nvSpPr>
          <p:spPr>
            <a:xfrm flipV="1">
              <a:off x="1625760" y="4824720"/>
              <a:ext cx="1080" cy="1702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"/>
            <p:cNvSpPr/>
            <p:nvPr/>
          </p:nvSpPr>
          <p:spPr>
            <a:xfrm>
              <a:off x="1603440" y="4825080"/>
              <a:ext cx="439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"/>
            <p:cNvSpPr/>
            <p:nvPr/>
          </p:nvSpPr>
          <p:spPr>
            <a:xfrm flipV="1">
              <a:off x="1934280" y="5076000"/>
              <a:ext cx="1440" cy="1753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"/>
            <p:cNvSpPr/>
            <p:nvPr/>
          </p:nvSpPr>
          <p:spPr>
            <a:xfrm>
              <a:off x="1912320" y="5076360"/>
              <a:ext cx="453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"/>
            <p:cNvSpPr/>
            <p:nvPr/>
          </p:nvSpPr>
          <p:spPr>
            <a:xfrm flipV="1">
              <a:off x="2246040" y="4925880"/>
              <a:ext cx="1440" cy="184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"/>
            <p:cNvSpPr/>
            <p:nvPr/>
          </p:nvSpPr>
          <p:spPr>
            <a:xfrm>
              <a:off x="2224080" y="4926240"/>
              <a:ext cx="4500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"/>
            <p:cNvSpPr/>
            <p:nvPr/>
          </p:nvSpPr>
          <p:spPr>
            <a:xfrm flipV="1">
              <a:off x="2556360" y="4993920"/>
              <a:ext cx="1080" cy="630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200" bIns="16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"/>
            <p:cNvSpPr/>
            <p:nvPr/>
          </p:nvSpPr>
          <p:spPr>
            <a:xfrm>
              <a:off x="2535840" y="4994280"/>
              <a:ext cx="4392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"/>
            <p:cNvSpPr/>
            <p:nvPr/>
          </p:nvSpPr>
          <p:spPr>
            <a:xfrm flipV="1">
              <a:off x="2866680" y="5167800"/>
              <a:ext cx="1080" cy="266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"/>
            <p:cNvSpPr/>
            <p:nvPr/>
          </p:nvSpPr>
          <p:spPr>
            <a:xfrm>
              <a:off x="2844360" y="5167800"/>
              <a:ext cx="453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"/>
            <p:cNvSpPr/>
            <p:nvPr/>
          </p:nvSpPr>
          <p:spPr>
            <a:xfrm>
              <a:off x="1161360" y="4692240"/>
              <a:ext cx="1080" cy="970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"/>
            <p:cNvSpPr/>
            <p:nvPr/>
          </p:nvSpPr>
          <p:spPr>
            <a:xfrm>
              <a:off x="1143720" y="5663520"/>
              <a:ext cx="172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"/>
            <p:cNvSpPr/>
            <p:nvPr/>
          </p:nvSpPr>
          <p:spPr>
            <a:xfrm>
              <a:off x="1143720" y="5500800"/>
              <a:ext cx="172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"/>
            <p:cNvSpPr/>
            <p:nvPr/>
          </p:nvSpPr>
          <p:spPr>
            <a:xfrm>
              <a:off x="1143720" y="5341680"/>
              <a:ext cx="172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"/>
            <p:cNvSpPr/>
            <p:nvPr/>
          </p:nvSpPr>
          <p:spPr>
            <a:xfrm>
              <a:off x="1143720" y="5178960"/>
              <a:ext cx="172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"/>
            <p:cNvSpPr/>
            <p:nvPr/>
          </p:nvSpPr>
          <p:spPr>
            <a:xfrm>
              <a:off x="1143720" y="5016240"/>
              <a:ext cx="172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"/>
            <p:cNvSpPr/>
            <p:nvPr/>
          </p:nvSpPr>
          <p:spPr>
            <a:xfrm>
              <a:off x="1143720" y="4855320"/>
              <a:ext cx="172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"/>
            <p:cNvSpPr/>
            <p:nvPr/>
          </p:nvSpPr>
          <p:spPr>
            <a:xfrm>
              <a:off x="1143720" y="4692240"/>
              <a:ext cx="172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"/>
            <p:cNvSpPr/>
            <p:nvPr/>
          </p:nvSpPr>
          <p:spPr>
            <a:xfrm>
              <a:off x="1161360" y="5663520"/>
              <a:ext cx="1856160" cy="1440"/>
            </a:xfrm>
            <a:prstGeom prst="line">
              <a:avLst/>
            </a:prstGeom>
            <a:ln w="18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"/>
            <p:cNvSpPr/>
            <p:nvPr/>
          </p:nvSpPr>
          <p:spPr>
            <a:xfrm flipV="1">
              <a:off x="1161360" y="5663520"/>
              <a:ext cx="1080" cy="252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"/>
            <p:cNvSpPr/>
            <p:nvPr/>
          </p:nvSpPr>
          <p:spPr>
            <a:xfrm flipV="1">
              <a:off x="1469880" y="5663520"/>
              <a:ext cx="1440" cy="252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"/>
            <p:cNvSpPr/>
            <p:nvPr/>
          </p:nvSpPr>
          <p:spPr>
            <a:xfrm flipV="1">
              <a:off x="1781280" y="5663520"/>
              <a:ext cx="1440" cy="252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"/>
            <p:cNvSpPr/>
            <p:nvPr/>
          </p:nvSpPr>
          <p:spPr>
            <a:xfrm flipV="1">
              <a:off x="2091600" y="5663520"/>
              <a:ext cx="1440" cy="252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"/>
            <p:cNvSpPr/>
            <p:nvPr/>
          </p:nvSpPr>
          <p:spPr>
            <a:xfrm flipV="1">
              <a:off x="2401920" y="5663520"/>
              <a:ext cx="1080" cy="252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"/>
            <p:cNvSpPr/>
            <p:nvPr/>
          </p:nvSpPr>
          <p:spPr>
            <a:xfrm flipV="1">
              <a:off x="2712240" y="5663520"/>
              <a:ext cx="1080" cy="252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"/>
            <p:cNvSpPr/>
            <p:nvPr/>
          </p:nvSpPr>
          <p:spPr>
            <a:xfrm flipV="1">
              <a:off x="3020760" y="5663520"/>
              <a:ext cx="1080" cy="252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"/>
            <p:cNvSpPr/>
            <p:nvPr/>
          </p:nvSpPr>
          <p:spPr>
            <a:xfrm>
              <a:off x="1951560" y="4476240"/>
              <a:ext cx="2858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MMP 1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"/>
            <p:cNvSpPr/>
            <p:nvPr/>
          </p:nvSpPr>
          <p:spPr>
            <a:xfrm>
              <a:off x="1077120" y="56127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"/>
            <p:cNvSpPr/>
            <p:nvPr/>
          </p:nvSpPr>
          <p:spPr>
            <a:xfrm>
              <a:off x="1029240" y="54504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"/>
            <p:cNvSpPr/>
            <p:nvPr/>
          </p:nvSpPr>
          <p:spPr>
            <a:xfrm>
              <a:off x="1029240" y="52891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"/>
            <p:cNvSpPr/>
            <p:nvPr/>
          </p:nvSpPr>
          <p:spPr>
            <a:xfrm>
              <a:off x="1029240" y="51267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"/>
            <p:cNvSpPr/>
            <p:nvPr/>
          </p:nvSpPr>
          <p:spPr>
            <a:xfrm>
              <a:off x="1029240" y="49640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"/>
            <p:cNvSpPr/>
            <p:nvPr/>
          </p:nvSpPr>
          <p:spPr>
            <a:xfrm>
              <a:off x="1077120" y="480312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"/>
            <p:cNvSpPr/>
            <p:nvPr/>
          </p:nvSpPr>
          <p:spPr>
            <a:xfrm>
              <a:off x="1029240" y="46404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"/>
            <p:cNvSpPr/>
            <p:nvPr/>
          </p:nvSpPr>
          <p:spPr>
            <a:xfrm rot="5400000">
              <a:off x="1235880" y="5795280"/>
              <a:ext cx="235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"/>
            <p:cNvSpPr/>
            <p:nvPr/>
          </p:nvSpPr>
          <p:spPr>
            <a:xfrm rot="5400000">
              <a:off x="1204200" y="5757480"/>
              <a:ext cx="160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RN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"/>
            <p:cNvSpPr/>
            <p:nvPr/>
          </p:nvSpPr>
          <p:spPr>
            <a:xfrm rot="5400000">
              <a:off x="1548000" y="582984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"/>
            <p:cNvSpPr/>
            <p:nvPr/>
          </p:nvSpPr>
          <p:spPr>
            <a:xfrm rot="5400000">
              <a:off x="1476720" y="583560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"/>
            <p:cNvSpPr/>
            <p:nvPr/>
          </p:nvSpPr>
          <p:spPr>
            <a:xfrm rot="5400000">
              <a:off x="1485720" y="5756400"/>
              <a:ext cx="1548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"/>
            <p:cNvSpPr/>
            <p:nvPr/>
          </p:nvSpPr>
          <p:spPr>
            <a:xfrm rot="5400000">
              <a:off x="1858320" y="582984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"/>
            <p:cNvSpPr/>
            <p:nvPr/>
          </p:nvSpPr>
          <p:spPr>
            <a:xfrm rot="5400000">
              <a:off x="1785240" y="583560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"/>
            <p:cNvSpPr/>
            <p:nvPr/>
          </p:nvSpPr>
          <p:spPr>
            <a:xfrm rot="5400000">
              <a:off x="1785960" y="576216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Long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"/>
            <p:cNvSpPr/>
            <p:nvPr/>
          </p:nvSpPr>
          <p:spPr>
            <a:xfrm rot="5400000">
              <a:off x="2156400" y="5838840"/>
              <a:ext cx="322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"/>
            <p:cNvSpPr/>
            <p:nvPr/>
          </p:nvSpPr>
          <p:spPr>
            <a:xfrm rot="5400000">
              <a:off x="2095560" y="583560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"/>
            <p:cNvSpPr/>
            <p:nvPr/>
          </p:nvSpPr>
          <p:spPr>
            <a:xfrm rot="5400000">
              <a:off x="2090160" y="5771520"/>
              <a:ext cx="183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Short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"/>
            <p:cNvSpPr/>
            <p:nvPr/>
          </p:nvSpPr>
          <p:spPr>
            <a:xfrm rot="5400000">
              <a:off x="2478600" y="582984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"/>
            <p:cNvSpPr/>
            <p:nvPr/>
          </p:nvSpPr>
          <p:spPr>
            <a:xfrm rot="5400000">
              <a:off x="2406240" y="583560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"/>
            <p:cNvSpPr/>
            <p:nvPr/>
          </p:nvSpPr>
          <p:spPr>
            <a:xfrm rot="5400000">
              <a:off x="2359440" y="5809680"/>
              <a:ext cx="26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4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"/>
            <p:cNvSpPr/>
            <p:nvPr/>
          </p:nvSpPr>
          <p:spPr>
            <a:xfrm rot="5400000">
              <a:off x="2787120" y="582984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"/>
            <p:cNvSpPr/>
            <p:nvPr/>
          </p:nvSpPr>
          <p:spPr>
            <a:xfrm rot="5400000">
              <a:off x="2763360" y="5788440"/>
              <a:ext cx="217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Empt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"/>
            <p:cNvSpPr/>
            <p:nvPr/>
          </p:nvSpPr>
          <p:spPr>
            <a:xfrm rot="5400000">
              <a:off x="2693160" y="5790600"/>
              <a:ext cx="22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Vector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"/>
            <p:cNvSpPr/>
            <p:nvPr/>
          </p:nvSpPr>
          <p:spPr>
            <a:xfrm rot="16200000">
              <a:off x="807480" y="5139000"/>
              <a:ext cx="329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gene/18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86" name=""/>
          <p:cNvGrpSpPr/>
          <p:nvPr/>
        </p:nvGrpSpPr>
        <p:grpSpPr>
          <a:xfrm>
            <a:off x="3573360" y="4429080"/>
            <a:ext cx="2340000" cy="1709640"/>
            <a:chOff x="3573360" y="4429080"/>
            <a:chExt cx="2340000" cy="1709640"/>
          </a:xfrm>
        </p:grpSpPr>
        <p:sp>
          <p:nvSpPr>
            <p:cNvPr id="387" name=""/>
            <p:cNvSpPr/>
            <p:nvPr/>
          </p:nvSpPr>
          <p:spPr>
            <a:xfrm>
              <a:off x="3573360" y="4429080"/>
              <a:ext cx="2340000" cy="170964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"/>
            <p:cNvSpPr/>
            <p:nvPr/>
          </p:nvSpPr>
          <p:spPr>
            <a:xfrm flipV="1">
              <a:off x="3821760" y="4628880"/>
              <a:ext cx="1440" cy="1067400"/>
            </a:xfrm>
            <a:prstGeom prst="line">
              <a:avLst/>
            </a:prstGeom>
            <a:ln w="64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"/>
            <p:cNvSpPr/>
            <p:nvPr/>
          </p:nvSpPr>
          <p:spPr>
            <a:xfrm>
              <a:off x="3915000" y="5635440"/>
              <a:ext cx="125640" cy="61200"/>
            </a:xfrm>
            <a:prstGeom prst="rect">
              <a:avLst/>
            </a:prstGeom>
            <a:solidFill>
              <a:srgbClr val="9999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400" bIns="14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"/>
            <p:cNvSpPr/>
            <p:nvPr/>
          </p:nvSpPr>
          <p:spPr>
            <a:xfrm>
              <a:off x="3917880" y="5638680"/>
              <a:ext cx="119880" cy="5508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280" bIns="8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"/>
            <p:cNvSpPr/>
            <p:nvPr/>
          </p:nvSpPr>
          <p:spPr>
            <a:xfrm>
              <a:off x="4227120" y="5031360"/>
              <a:ext cx="127440" cy="6652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"/>
            <p:cNvSpPr/>
            <p:nvPr/>
          </p:nvSpPr>
          <p:spPr>
            <a:xfrm>
              <a:off x="4230000" y="5034600"/>
              <a:ext cx="121320" cy="65916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"/>
            <p:cNvSpPr/>
            <p:nvPr/>
          </p:nvSpPr>
          <p:spPr>
            <a:xfrm>
              <a:off x="4540680" y="5422320"/>
              <a:ext cx="127440" cy="2743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"/>
            <p:cNvSpPr/>
            <p:nvPr/>
          </p:nvSpPr>
          <p:spPr>
            <a:xfrm>
              <a:off x="4543920" y="5425560"/>
              <a:ext cx="121320" cy="26784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"/>
            <p:cNvSpPr/>
            <p:nvPr/>
          </p:nvSpPr>
          <p:spPr>
            <a:xfrm>
              <a:off x="4854240" y="5168520"/>
              <a:ext cx="126000" cy="528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"/>
            <p:cNvSpPr/>
            <p:nvPr/>
          </p:nvSpPr>
          <p:spPr>
            <a:xfrm>
              <a:off x="4857480" y="5171760"/>
              <a:ext cx="119520" cy="52164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"/>
            <p:cNvSpPr/>
            <p:nvPr/>
          </p:nvSpPr>
          <p:spPr>
            <a:xfrm>
              <a:off x="5167800" y="5073840"/>
              <a:ext cx="124560" cy="622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"/>
            <p:cNvSpPr/>
            <p:nvPr/>
          </p:nvSpPr>
          <p:spPr>
            <a:xfrm>
              <a:off x="5171040" y="5077080"/>
              <a:ext cx="118080" cy="61632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"/>
            <p:cNvSpPr/>
            <p:nvPr/>
          </p:nvSpPr>
          <p:spPr>
            <a:xfrm>
              <a:off x="5479560" y="5442840"/>
              <a:ext cx="126000" cy="253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"/>
            <p:cNvSpPr/>
            <p:nvPr/>
          </p:nvSpPr>
          <p:spPr>
            <a:xfrm>
              <a:off x="5482800" y="5446080"/>
              <a:ext cx="119520" cy="24732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"/>
            <p:cNvSpPr/>
            <p:nvPr/>
          </p:nvSpPr>
          <p:spPr>
            <a:xfrm flipV="1">
              <a:off x="3976560" y="5619240"/>
              <a:ext cx="1080" cy="15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320" bIns="-31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"/>
            <p:cNvSpPr/>
            <p:nvPr/>
          </p:nvSpPr>
          <p:spPr>
            <a:xfrm>
              <a:off x="3956040" y="5619600"/>
              <a:ext cx="424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"/>
            <p:cNvSpPr/>
            <p:nvPr/>
          </p:nvSpPr>
          <p:spPr>
            <a:xfrm flipV="1">
              <a:off x="4290120" y="4758480"/>
              <a:ext cx="1080" cy="2728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"/>
            <p:cNvSpPr/>
            <p:nvPr/>
          </p:nvSpPr>
          <p:spPr>
            <a:xfrm>
              <a:off x="4269600" y="4758480"/>
              <a:ext cx="424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"/>
            <p:cNvSpPr/>
            <p:nvPr/>
          </p:nvSpPr>
          <p:spPr>
            <a:xfrm flipV="1">
              <a:off x="4603680" y="5308560"/>
              <a:ext cx="1080" cy="1134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"/>
            <p:cNvSpPr/>
            <p:nvPr/>
          </p:nvSpPr>
          <p:spPr>
            <a:xfrm>
              <a:off x="4583160" y="5308920"/>
              <a:ext cx="424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"/>
            <p:cNvSpPr/>
            <p:nvPr/>
          </p:nvSpPr>
          <p:spPr>
            <a:xfrm flipV="1">
              <a:off x="4917240" y="4994640"/>
              <a:ext cx="1440" cy="1731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"/>
            <p:cNvSpPr/>
            <p:nvPr/>
          </p:nvSpPr>
          <p:spPr>
            <a:xfrm>
              <a:off x="4896720" y="4995000"/>
              <a:ext cx="4248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"/>
            <p:cNvSpPr/>
            <p:nvPr/>
          </p:nvSpPr>
          <p:spPr>
            <a:xfrm flipV="1">
              <a:off x="5229360" y="4939560"/>
              <a:ext cx="1440" cy="1339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"/>
            <p:cNvSpPr/>
            <p:nvPr/>
          </p:nvSpPr>
          <p:spPr>
            <a:xfrm>
              <a:off x="5208840" y="4939560"/>
              <a:ext cx="4104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"/>
            <p:cNvSpPr/>
            <p:nvPr/>
          </p:nvSpPr>
          <p:spPr>
            <a:xfrm flipV="1">
              <a:off x="5541120" y="5436000"/>
              <a:ext cx="1440" cy="61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680" bIns="-406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"/>
            <p:cNvSpPr/>
            <p:nvPr/>
          </p:nvSpPr>
          <p:spPr>
            <a:xfrm>
              <a:off x="5520960" y="5436360"/>
              <a:ext cx="424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"/>
            <p:cNvSpPr/>
            <p:nvPr/>
          </p:nvSpPr>
          <p:spPr>
            <a:xfrm>
              <a:off x="3821760" y="4629240"/>
              <a:ext cx="1440" cy="1067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"/>
            <p:cNvSpPr/>
            <p:nvPr/>
          </p:nvSpPr>
          <p:spPr>
            <a:xfrm>
              <a:off x="3806280" y="5697000"/>
              <a:ext cx="154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"/>
            <p:cNvSpPr/>
            <p:nvPr/>
          </p:nvSpPr>
          <p:spPr>
            <a:xfrm>
              <a:off x="3806280" y="5564520"/>
              <a:ext cx="154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"/>
            <p:cNvSpPr/>
            <p:nvPr/>
          </p:nvSpPr>
          <p:spPr>
            <a:xfrm>
              <a:off x="3806280" y="5431680"/>
              <a:ext cx="154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"/>
            <p:cNvSpPr/>
            <p:nvPr/>
          </p:nvSpPr>
          <p:spPr>
            <a:xfrm>
              <a:off x="3806280" y="5296320"/>
              <a:ext cx="154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"/>
            <p:cNvSpPr/>
            <p:nvPr/>
          </p:nvSpPr>
          <p:spPr>
            <a:xfrm>
              <a:off x="3806280" y="5163840"/>
              <a:ext cx="154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"/>
            <p:cNvSpPr/>
            <p:nvPr/>
          </p:nvSpPr>
          <p:spPr>
            <a:xfrm>
              <a:off x="3806280" y="5031360"/>
              <a:ext cx="154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"/>
            <p:cNvSpPr/>
            <p:nvPr/>
          </p:nvSpPr>
          <p:spPr>
            <a:xfrm>
              <a:off x="3806280" y="4897080"/>
              <a:ext cx="154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1" name=""/>
            <p:cNvSpPr/>
            <p:nvPr/>
          </p:nvSpPr>
          <p:spPr>
            <a:xfrm>
              <a:off x="3806280" y="4763160"/>
              <a:ext cx="154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2" name=""/>
            <p:cNvSpPr/>
            <p:nvPr/>
          </p:nvSpPr>
          <p:spPr>
            <a:xfrm>
              <a:off x="3806280" y="4629240"/>
              <a:ext cx="1548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3" name=""/>
            <p:cNvSpPr/>
            <p:nvPr/>
          </p:nvSpPr>
          <p:spPr>
            <a:xfrm>
              <a:off x="3821760" y="5697000"/>
              <a:ext cx="1875240" cy="1080"/>
            </a:xfrm>
            <a:prstGeom prst="line">
              <a:avLst/>
            </a:prstGeom>
            <a:ln w="18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4" name=""/>
            <p:cNvSpPr/>
            <p:nvPr/>
          </p:nvSpPr>
          <p:spPr>
            <a:xfrm flipV="1">
              <a:off x="3821760" y="5696640"/>
              <a:ext cx="144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5" name=""/>
            <p:cNvSpPr/>
            <p:nvPr/>
          </p:nvSpPr>
          <p:spPr>
            <a:xfrm flipV="1">
              <a:off x="4135680" y="5696640"/>
              <a:ext cx="108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6" name=""/>
            <p:cNvSpPr/>
            <p:nvPr/>
          </p:nvSpPr>
          <p:spPr>
            <a:xfrm flipV="1">
              <a:off x="4449240" y="5696640"/>
              <a:ext cx="144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7" name=""/>
            <p:cNvSpPr/>
            <p:nvPr/>
          </p:nvSpPr>
          <p:spPr>
            <a:xfrm flipV="1">
              <a:off x="4761360" y="5696640"/>
              <a:ext cx="108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8" name=""/>
            <p:cNvSpPr/>
            <p:nvPr/>
          </p:nvSpPr>
          <p:spPr>
            <a:xfrm flipV="1">
              <a:off x="5074920" y="5696640"/>
              <a:ext cx="144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9" name=""/>
            <p:cNvSpPr/>
            <p:nvPr/>
          </p:nvSpPr>
          <p:spPr>
            <a:xfrm flipV="1">
              <a:off x="5386680" y="5696640"/>
              <a:ext cx="144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0" name=""/>
            <p:cNvSpPr/>
            <p:nvPr/>
          </p:nvSpPr>
          <p:spPr>
            <a:xfrm flipV="1">
              <a:off x="5700600" y="5696640"/>
              <a:ext cx="1080" cy="234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1" name=""/>
            <p:cNvSpPr/>
            <p:nvPr/>
          </p:nvSpPr>
          <p:spPr>
            <a:xfrm>
              <a:off x="4626360" y="4474800"/>
              <a:ext cx="2858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MMP 1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"/>
            <p:cNvSpPr/>
            <p:nvPr/>
          </p:nvSpPr>
          <p:spPr>
            <a:xfrm>
              <a:off x="3741120" y="564624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"/>
            <p:cNvSpPr/>
            <p:nvPr/>
          </p:nvSpPr>
          <p:spPr>
            <a:xfrm>
              <a:off x="3696480" y="55141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4" name=""/>
            <p:cNvSpPr/>
            <p:nvPr/>
          </p:nvSpPr>
          <p:spPr>
            <a:xfrm>
              <a:off x="3741120" y="538128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5" name=""/>
            <p:cNvSpPr/>
            <p:nvPr/>
          </p:nvSpPr>
          <p:spPr>
            <a:xfrm>
              <a:off x="3696480" y="52459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6" name=""/>
            <p:cNvSpPr/>
            <p:nvPr/>
          </p:nvSpPr>
          <p:spPr>
            <a:xfrm>
              <a:off x="3741120" y="511308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7" name=""/>
            <p:cNvSpPr/>
            <p:nvPr/>
          </p:nvSpPr>
          <p:spPr>
            <a:xfrm>
              <a:off x="3696480" y="49806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"/>
            <p:cNvSpPr/>
            <p:nvPr/>
          </p:nvSpPr>
          <p:spPr>
            <a:xfrm>
              <a:off x="3741120" y="484668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"/>
            <p:cNvSpPr/>
            <p:nvPr/>
          </p:nvSpPr>
          <p:spPr>
            <a:xfrm>
              <a:off x="3696480" y="47124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"/>
            <p:cNvSpPr/>
            <p:nvPr/>
          </p:nvSpPr>
          <p:spPr>
            <a:xfrm>
              <a:off x="3741120" y="457884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"/>
            <p:cNvSpPr/>
            <p:nvPr/>
          </p:nvSpPr>
          <p:spPr>
            <a:xfrm rot="5400000">
              <a:off x="3895920" y="5827320"/>
              <a:ext cx="235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2" name=""/>
            <p:cNvSpPr/>
            <p:nvPr/>
          </p:nvSpPr>
          <p:spPr>
            <a:xfrm rot="5400000">
              <a:off x="3872160" y="5791320"/>
              <a:ext cx="160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RN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3" name=""/>
            <p:cNvSpPr/>
            <p:nvPr/>
          </p:nvSpPr>
          <p:spPr>
            <a:xfrm rot="5400000">
              <a:off x="4211640" y="586188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4" name=""/>
            <p:cNvSpPr/>
            <p:nvPr/>
          </p:nvSpPr>
          <p:spPr>
            <a:xfrm rot="5400000">
              <a:off x="4140000" y="586440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"/>
            <p:cNvSpPr/>
            <p:nvPr/>
          </p:nvSpPr>
          <p:spPr>
            <a:xfrm rot="5400000">
              <a:off x="4155480" y="5787000"/>
              <a:ext cx="1548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"/>
            <p:cNvSpPr/>
            <p:nvPr/>
          </p:nvSpPr>
          <p:spPr>
            <a:xfrm rot="5400000">
              <a:off x="4524840" y="586188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"/>
            <p:cNvSpPr/>
            <p:nvPr/>
          </p:nvSpPr>
          <p:spPr>
            <a:xfrm rot="5400000">
              <a:off x="4453560" y="586440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"/>
            <p:cNvSpPr/>
            <p:nvPr/>
          </p:nvSpPr>
          <p:spPr>
            <a:xfrm rot="5400000">
              <a:off x="4459320" y="579708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Long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"/>
            <p:cNvSpPr/>
            <p:nvPr/>
          </p:nvSpPr>
          <p:spPr>
            <a:xfrm rot="5400000">
              <a:off x="4828320" y="5874120"/>
              <a:ext cx="322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0" name=""/>
            <p:cNvSpPr/>
            <p:nvPr/>
          </p:nvSpPr>
          <p:spPr>
            <a:xfrm rot="5400000">
              <a:off x="4767120" y="586440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"/>
            <p:cNvSpPr/>
            <p:nvPr/>
          </p:nvSpPr>
          <p:spPr>
            <a:xfrm rot="5400000">
              <a:off x="4766760" y="5800320"/>
              <a:ext cx="183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Short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"/>
            <p:cNvSpPr/>
            <p:nvPr/>
          </p:nvSpPr>
          <p:spPr>
            <a:xfrm rot="5400000">
              <a:off x="5149440" y="586188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"/>
            <p:cNvSpPr/>
            <p:nvPr/>
          </p:nvSpPr>
          <p:spPr>
            <a:xfrm rot="5400000">
              <a:off x="5079240" y="586440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"/>
            <p:cNvSpPr/>
            <p:nvPr/>
          </p:nvSpPr>
          <p:spPr>
            <a:xfrm rot="5400000">
              <a:off x="5037840" y="5843880"/>
              <a:ext cx="26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4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"/>
            <p:cNvSpPr/>
            <p:nvPr/>
          </p:nvSpPr>
          <p:spPr>
            <a:xfrm rot="5400000">
              <a:off x="5463000" y="586188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"/>
            <p:cNvSpPr/>
            <p:nvPr/>
          </p:nvSpPr>
          <p:spPr>
            <a:xfrm rot="5400000">
              <a:off x="5436720" y="5820480"/>
              <a:ext cx="217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Empt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"/>
            <p:cNvSpPr/>
            <p:nvPr/>
          </p:nvSpPr>
          <p:spPr>
            <a:xfrm rot="5400000">
              <a:off x="5373360" y="5819400"/>
              <a:ext cx="22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Vector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8" name=""/>
            <p:cNvSpPr/>
            <p:nvPr/>
          </p:nvSpPr>
          <p:spPr>
            <a:xfrm rot="16200000">
              <a:off x="3482280" y="5116320"/>
              <a:ext cx="329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gene/18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59" name=""/>
          <p:cNvGrpSpPr/>
          <p:nvPr/>
        </p:nvGrpSpPr>
        <p:grpSpPr>
          <a:xfrm>
            <a:off x="896760" y="6256440"/>
            <a:ext cx="2339640" cy="1709640"/>
            <a:chOff x="896760" y="6256440"/>
            <a:chExt cx="2339640" cy="1709640"/>
          </a:xfrm>
        </p:grpSpPr>
        <p:sp>
          <p:nvSpPr>
            <p:cNvPr id="460" name=""/>
            <p:cNvSpPr/>
            <p:nvPr/>
          </p:nvSpPr>
          <p:spPr>
            <a:xfrm>
              <a:off x="914040" y="6256440"/>
              <a:ext cx="2322360" cy="1709640"/>
            </a:xfrm>
            <a:prstGeom prst="rect">
              <a:avLst/>
            </a:prstGeom>
            <a:noFill/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1" name=""/>
            <p:cNvSpPr/>
            <p:nvPr/>
          </p:nvSpPr>
          <p:spPr>
            <a:xfrm flipV="1">
              <a:off x="1218600" y="6488280"/>
              <a:ext cx="1440" cy="1037880"/>
            </a:xfrm>
            <a:prstGeom prst="line">
              <a:avLst/>
            </a:prstGeom>
            <a:ln w="64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2" name=""/>
            <p:cNvSpPr/>
            <p:nvPr/>
          </p:nvSpPr>
          <p:spPr>
            <a:xfrm>
              <a:off x="1307880" y="7033680"/>
              <a:ext cx="120240" cy="492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3" name=""/>
            <p:cNvSpPr/>
            <p:nvPr/>
          </p:nvSpPr>
          <p:spPr>
            <a:xfrm>
              <a:off x="1311120" y="7036560"/>
              <a:ext cx="114120" cy="48672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4" name=""/>
            <p:cNvSpPr/>
            <p:nvPr/>
          </p:nvSpPr>
          <p:spPr>
            <a:xfrm>
              <a:off x="1609920" y="6953400"/>
              <a:ext cx="121680" cy="5731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"/>
            <p:cNvSpPr/>
            <p:nvPr/>
          </p:nvSpPr>
          <p:spPr>
            <a:xfrm>
              <a:off x="1613160" y="6956280"/>
              <a:ext cx="115560" cy="56700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"/>
            <p:cNvSpPr/>
            <p:nvPr/>
          </p:nvSpPr>
          <p:spPr>
            <a:xfrm>
              <a:off x="1913040" y="7138080"/>
              <a:ext cx="120600" cy="3884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"/>
            <p:cNvSpPr/>
            <p:nvPr/>
          </p:nvSpPr>
          <p:spPr>
            <a:xfrm>
              <a:off x="1916280" y="7141320"/>
              <a:ext cx="114120" cy="38232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"/>
            <p:cNvSpPr/>
            <p:nvPr/>
          </p:nvSpPr>
          <p:spPr>
            <a:xfrm>
              <a:off x="2215080" y="7125120"/>
              <a:ext cx="120600" cy="4010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9" name=""/>
            <p:cNvSpPr/>
            <p:nvPr/>
          </p:nvSpPr>
          <p:spPr>
            <a:xfrm>
              <a:off x="2218320" y="7128360"/>
              <a:ext cx="114120" cy="39492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0" name=""/>
            <p:cNvSpPr/>
            <p:nvPr/>
          </p:nvSpPr>
          <p:spPr>
            <a:xfrm>
              <a:off x="2517120" y="6812280"/>
              <a:ext cx="120240" cy="713880"/>
            </a:xfrm>
            <a:prstGeom prst="rect">
              <a:avLst/>
            </a:prstGeom>
            <a:solidFill>
              <a:srgbClr val="9999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1" name=""/>
            <p:cNvSpPr/>
            <p:nvPr/>
          </p:nvSpPr>
          <p:spPr>
            <a:xfrm>
              <a:off x="2520000" y="6815520"/>
              <a:ext cx="114120" cy="70776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2" name=""/>
            <p:cNvSpPr/>
            <p:nvPr/>
          </p:nvSpPr>
          <p:spPr>
            <a:xfrm>
              <a:off x="2819160" y="7300800"/>
              <a:ext cx="121680" cy="2257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3" name=""/>
            <p:cNvSpPr/>
            <p:nvPr/>
          </p:nvSpPr>
          <p:spPr>
            <a:xfrm>
              <a:off x="2822040" y="7304040"/>
              <a:ext cx="115920" cy="21960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4" name=""/>
            <p:cNvSpPr/>
            <p:nvPr/>
          </p:nvSpPr>
          <p:spPr>
            <a:xfrm flipV="1">
              <a:off x="1369080" y="6834240"/>
              <a:ext cx="1080" cy="199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5" name=""/>
            <p:cNvSpPr/>
            <p:nvPr/>
          </p:nvSpPr>
          <p:spPr>
            <a:xfrm>
              <a:off x="1345680" y="6834600"/>
              <a:ext cx="4680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6" name=""/>
            <p:cNvSpPr/>
            <p:nvPr/>
          </p:nvSpPr>
          <p:spPr>
            <a:xfrm flipV="1">
              <a:off x="1670760" y="6729840"/>
              <a:ext cx="1080" cy="222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7" name=""/>
            <p:cNvSpPr/>
            <p:nvPr/>
          </p:nvSpPr>
          <p:spPr>
            <a:xfrm>
              <a:off x="1647360" y="6730200"/>
              <a:ext cx="4680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8" name=""/>
            <p:cNvSpPr/>
            <p:nvPr/>
          </p:nvSpPr>
          <p:spPr>
            <a:xfrm flipV="1">
              <a:off x="1971360" y="6950160"/>
              <a:ext cx="1080" cy="1879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9" name=""/>
            <p:cNvSpPr/>
            <p:nvPr/>
          </p:nvSpPr>
          <p:spPr>
            <a:xfrm>
              <a:off x="1949400" y="6950160"/>
              <a:ext cx="4680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0" name=""/>
            <p:cNvSpPr/>
            <p:nvPr/>
          </p:nvSpPr>
          <p:spPr>
            <a:xfrm flipV="1">
              <a:off x="2274480" y="7044840"/>
              <a:ext cx="1080" cy="799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120" bIns="33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1" name=""/>
            <p:cNvSpPr/>
            <p:nvPr/>
          </p:nvSpPr>
          <p:spPr>
            <a:xfrm>
              <a:off x="2252520" y="7044840"/>
              <a:ext cx="47160" cy="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2" name=""/>
            <p:cNvSpPr/>
            <p:nvPr/>
          </p:nvSpPr>
          <p:spPr>
            <a:xfrm flipV="1">
              <a:off x="2575080" y="6542280"/>
              <a:ext cx="1080" cy="2700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3" name=""/>
            <p:cNvSpPr/>
            <p:nvPr/>
          </p:nvSpPr>
          <p:spPr>
            <a:xfrm>
              <a:off x="2553120" y="6542280"/>
              <a:ext cx="4680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4" name=""/>
            <p:cNvSpPr/>
            <p:nvPr/>
          </p:nvSpPr>
          <p:spPr>
            <a:xfrm flipV="1">
              <a:off x="2878200" y="7259760"/>
              <a:ext cx="1440" cy="41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5" name=""/>
            <p:cNvSpPr/>
            <p:nvPr/>
          </p:nvSpPr>
          <p:spPr>
            <a:xfrm>
              <a:off x="2856240" y="7259760"/>
              <a:ext cx="471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6" name=""/>
            <p:cNvSpPr/>
            <p:nvPr/>
          </p:nvSpPr>
          <p:spPr>
            <a:xfrm>
              <a:off x="1218600" y="6488640"/>
              <a:ext cx="1440" cy="10378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7" name=""/>
            <p:cNvSpPr/>
            <p:nvPr/>
          </p:nvSpPr>
          <p:spPr>
            <a:xfrm>
              <a:off x="1201680" y="7526520"/>
              <a:ext cx="169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8" name=""/>
            <p:cNvSpPr/>
            <p:nvPr/>
          </p:nvSpPr>
          <p:spPr>
            <a:xfrm>
              <a:off x="1201680" y="7422120"/>
              <a:ext cx="169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9" name=""/>
            <p:cNvSpPr/>
            <p:nvPr/>
          </p:nvSpPr>
          <p:spPr>
            <a:xfrm>
              <a:off x="1201680" y="7318080"/>
              <a:ext cx="169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0" name=""/>
            <p:cNvSpPr/>
            <p:nvPr/>
          </p:nvSpPr>
          <p:spPr>
            <a:xfrm>
              <a:off x="1201680" y="7213680"/>
              <a:ext cx="169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1" name=""/>
            <p:cNvSpPr/>
            <p:nvPr/>
          </p:nvSpPr>
          <p:spPr>
            <a:xfrm>
              <a:off x="1201680" y="7111440"/>
              <a:ext cx="1692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2" name=""/>
            <p:cNvSpPr/>
            <p:nvPr/>
          </p:nvSpPr>
          <p:spPr>
            <a:xfrm>
              <a:off x="1201680" y="7007040"/>
              <a:ext cx="1692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3" name=""/>
            <p:cNvSpPr/>
            <p:nvPr/>
          </p:nvSpPr>
          <p:spPr>
            <a:xfrm>
              <a:off x="1201680" y="6902640"/>
              <a:ext cx="1692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4" name=""/>
            <p:cNvSpPr/>
            <p:nvPr/>
          </p:nvSpPr>
          <p:spPr>
            <a:xfrm>
              <a:off x="1201680" y="6800040"/>
              <a:ext cx="1692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5" name=""/>
            <p:cNvSpPr/>
            <p:nvPr/>
          </p:nvSpPr>
          <p:spPr>
            <a:xfrm>
              <a:off x="1201680" y="6695640"/>
              <a:ext cx="1692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6" name=""/>
            <p:cNvSpPr/>
            <p:nvPr/>
          </p:nvSpPr>
          <p:spPr>
            <a:xfrm>
              <a:off x="1201680" y="6591240"/>
              <a:ext cx="16920" cy="10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7" name=""/>
            <p:cNvSpPr/>
            <p:nvPr/>
          </p:nvSpPr>
          <p:spPr>
            <a:xfrm>
              <a:off x="1201680" y="6488640"/>
              <a:ext cx="169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"/>
            <p:cNvSpPr/>
            <p:nvPr/>
          </p:nvSpPr>
          <p:spPr>
            <a:xfrm>
              <a:off x="1218600" y="7526520"/>
              <a:ext cx="1819080" cy="1440"/>
            </a:xfrm>
            <a:prstGeom prst="line">
              <a:avLst/>
            </a:prstGeom>
            <a:ln w="18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"/>
            <p:cNvSpPr/>
            <p:nvPr/>
          </p:nvSpPr>
          <p:spPr>
            <a:xfrm flipV="1">
              <a:off x="1218600" y="7526520"/>
              <a:ext cx="1440" cy="23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"/>
            <p:cNvSpPr/>
            <p:nvPr/>
          </p:nvSpPr>
          <p:spPr>
            <a:xfrm flipV="1">
              <a:off x="1521000" y="7526520"/>
              <a:ext cx="1080" cy="23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"/>
            <p:cNvSpPr/>
            <p:nvPr/>
          </p:nvSpPr>
          <p:spPr>
            <a:xfrm flipV="1">
              <a:off x="1824120" y="7526520"/>
              <a:ext cx="1080" cy="23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"/>
            <p:cNvSpPr/>
            <p:nvPr/>
          </p:nvSpPr>
          <p:spPr>
            <a:xfrm flipV="1">
              <a:off x="2124720" y="7526520"/>
              <a:ext cx="1080" cy="23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"/>
            <p:cNvSpPr/>
            <p:nvPr/>
          </p:nvSpPr>
          <p:spPr>
            <a:xfrm flipV="1">
              <a:off x="2426400" y="7526520"/>
              <a:ext cx="1080" cy="23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"/>
            <p:cNvSpPr/>
            <p:nvPr/>
          </p:nvSpPr>
          <p:spPr>
            <a:xfrm flipV="1">
              <a:off x="2728440" y="7526520"/>
              <a:ext cx="1080" cy="23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"/>
            <p:cNvSpPr/>
            <p:nvPr/>
          </p:nvSpPr>
          <p:spPr>
            <a:xfrm flipV="1">
              <a:off x="3031560" y="7526520"/>
              <a:ext cx="1440" cy="23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6" name=""/>
            <p:cNvSpPr/>
            <p:nvPr/>
          </p:nvSpPr>
          <p:spPr>
            <a:xfrm>
              <a:off x="1915200" y="6305400"/>
              <a:ext cx="2854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MMP1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7" name=""/>
            <p:cNvSpPr/>
            <p:nvPr/>
          </p:nvSpPr>
          <p:spPr>
            <a:xfrm>
              <a:off x="1105560" y="747468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"/>
            <p:cNvSpPr/>
            <p:nvPr/>
          </p:nvSpPr>
          <p:spPr>
            <a:xfrm>
              <a:off x="1014840" y="7371720"/>
              <a:ext cx="150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0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"/>
            <p:cNvSpPr/>
            <p:nvPr/>
          </p:nvSpPr>
          <p:spPr>
            <a:xfrm>
              <a:off x="1014120" y="7267320"/>
              <a:ext cx="150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0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0" name=""/>
            <p:cNvSpPr/>
            <p:nvPr/>
          </p:nvSpPr>
          <p:spPr>
            <a:xfrm>
              <a:off x="1014120" y="7163280"/>
              <a:ext cx="150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0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"/>
            <p:cNvSpPr/>
            <p:nvPr/>
          </p:nvSpPr>
          <p:spPr>
            <a:xfrm>
              <a:off x="1014840" y="7058880"/>
              <a:ext cx="150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0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"/>
            <p:cNvSpPr/>
            <p:nvPr/>
          </p:nvSpPr>
          <p:spPr>
            <a:xfrm>
              <a:off x="1046160" y="69562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"/>
            <p:cNvSpPr/>
            <p:nvPr/>
          </p:nvSpPr>
          <p:spPr>
            <a:xfrm>
              <a:off x="1014120" y="6852240"/>
              <a:ext cx="150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1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"/>
            <p:cNvSpPr/>
            <p:nvPr/>
          </p:nvSpPr>
          <p:spPr>
            <a:xfrm>
              <a:off x="1014840" y="6747480"/>
              <a:ext cx="150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1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"/>
            <p:cNvSpPr/>
            <p:nvPr/>
          </p:nvSpPr>
          <p:spPr>
            <a:xfrm>
              <a:off x="1014120" y="6644880"/>
              <a:ext cx="150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"/>
            <p:cNvSpPr/>
            <p:nvPr/>
          </p:nvSpPr>
          <p:spPr>
            <a:xfrm>
              <a:off x="1014120" y="6540840"/>
              <a:ext cx="150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1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7" name=""/>
            <p:cNvSpPr/>
            <p:nvPr/>
          </p:nvSpPr>
          <p:spPr>
            <a:xfrm>
              <a:off x="1046160" y="64364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8" name=""/>
            <p:cNvSpPr/>
            <p:nvPr/>
          </p:nvSpPr>
          <p:spPr>
            <a:xfrm rot="5400000">
              <a:off x="1289520" y="7657560"/>
              <a:ext cx="2354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9" name=""/>
            <p:cNvSpPr/>
            <p:nvPr/>
          </p:nvSpPr>
          <p:spPr>
            <a:xfrm rot="5400000">
              <a:off x="1256400" y="7620480"/>
              <a:ext cx="1609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RN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0" name=""/>
            <p:cNvSpPr/>
            <p:nvPr/>
          </p:nvSpPr>
          <p:spPr>
            <a:xfrm rot="5400000">
              <a:off x="1596240" y="769140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1" name=""/>
            <p:cNvSpPr/>
            <p:nvPr/>
          </p:nvSpPr>
          <p:spPr>
            <a:xfrm rot="5400000">
              <a:off x="1518840" y="769716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2" name=""/>
            <p:cNvSpPr/>
            <p:nvPr/>
          </p:nvSpPr>
          <p:spPr>
            <a:xfrm rot="5400000">
              <a:off x="1526760" y="7619760"/>
              <a:ext cx="1548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3" name=""/>
            <p:cNvSpPr/>
            <p:nvPr/>
          </p:nvSpPr>
          <p:spPr>
            <a:xfrm rot="5400000">
              <a:off x="1896480" y="769140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4" name=""/>
            <p:cNvSpPr/>
            <p:nvPr/>
          </p:nvSpPr>
          <p:spPr>
            <a:xfrm rot="5400000">
              <a:off x="1820880" y="769716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5" name=""/>
            <p:cNvSpPr/>
            <p:nvPr/>
          </p:nvSpPr>
          <p:spPr>
            <a:xfrm rot="5400000">
              <a:off x="1820520" y="7626600"/>
              <a:ext cx="1713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Long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6" name=""/>
            <p:cNvSpPr/>
            <p:nvPr/>
          </p:nvSpPr>
          <p:spPr>
            <a:xfrm rot="5400000">
              <a:off x="2187720" y="7701840"/>
              <a:ext cx="322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7" name=""/>
            <p:cNvSpPr/>
            <p:nvPr/>
          </p:nvSpPr>
          <p:spPr>
            <a:xfrm rot="5400000">
              <a:off x="2124360" y="769716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8" name=""/>
            <p:cNvSpPr/>
            <p:nvPr/>
          </p:nvSpPr>
          <p:spPr>
            <a:xfrm rot="5400000">
              <a:off x="2116440" y="7634520"/>
              <a:ext cx="183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Short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9" name=""/>
            <p:cNvSpPr/>
            <p:nvPr/>
          </p:nvSpPr>
          <p:spPr>
            <a:xfrm rot="5400000">
              <a:off x="2502000" y="769140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"/>
            <p:cNvSpPr/>
            <p:nvPr/>
          </p:nvSpPr>
          <p:spPr>
            <a:xfrm rot="5400000">
              <a:off x="2426040" y="7697160"/>
              <a:ext cx="31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enascin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"/>
            <p:cNvSpPr/>
            <p:nvPr/>
          </p:nvSpPr>
          <p:spPr>
            <a:xfrm rot="5400000">
              <a:off x="2378520" y="7671960"/>
              <a:ext cx="2660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-14-1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"/>
            <p:cNvSpPr/>
            <p:nvPr/>
          </p:nvSpPr>
          <p:spPr>
            <a:xfrm rot="5400000">
              <a:off x="2803680" y="7691400"/>
              <a:ext cx="300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MCF-7 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"/>
            <p:cNvSpPr/>
            <p:nvPr/>
          </p:nvSpPr>
          <p:spPr>
            <a:xfrm rot="5400000">
              <a:off x="2775600" y="7650720"/>
              <a:ext cx="217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Empty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"/>
            <p:cNvSpPr/>
            <p:nvPr/>
          </p:nvSpPr>
          <p:spPr>
            <a:xfrm rot="5400000">
              <a:off x="2702520" y="7651080"/>
              <a:ext cx="221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Vector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"/>
            <p:cNvSpPr/>
            <p:nvPr/>
          </p:nvSpPr>
          <p:spPr>
            <a:xfrm rot="16200000">
              <a:off x="777600" y="6971760"/>
              <a:ext cx="3297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gene/18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36" name=""/>
          <p:cNvSpPr/>
          <p:nvPr/>
        </p:nvSpPr>
        <p:spPr>
          <a:xfrm>
            <a:off x="733320" y="403200"/>
            <a:ext cx="1387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Real time PCR dat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37" name=""/>
          <p:cNvGraphicFramePr/>
          <p:nvPr/>
        </p:nvGraphicFramePr>
        <p:xfrm>
          <a:off x="3570120" y="6234120"/>
          <a:ext cx="2362320" cy="176832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538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570120" y="6234120"/>
                    <a:ext cx="2362320" cy="1768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1-13T19:27:41Z</dcterms:created>
  <dc:creator>CRUK CRUK</dc:creator>
  <dc:description/>
  <dc:language>en-US</dc:language>
  <cp:lastModifiedBy>CRUK CRUK</cp:lastModifiedBy>
  <dcterms:modified xsi:type="dcterms:W3CDTF">2009-01-13T19:28:49Z</dcterms:modified>
  <cp:revision>1</cp:revision>
  <dc:subject/>
  <dc:title>PowerPoint Presentation</dc:title>
</cp:coreProperties>
</file>